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BF46D-B00A-4D98-A511-9B154AFAA5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2CE820-D8C9-4265-B5B4-0854453DA4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B6F42-99BB-4C06-A851-2F5E5ED309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A77627-8F35-4E3E-AB8B-8A5AE4AC34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A3910-0620-467B-BFD2-498C858FAA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A1F83-0A43-4BD7-9FEB-23EFF3BA7C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60A81-E1B6-49BF-B540-9F623CDBE3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CAEE5-9962-4C75-96AC-4AC9A89195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A8519A-514B-4FA2-A33A-B26D638445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7F62D2-107C-47A2-900E-239456CEC0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95163-4AD9-4DB0-A1CC-807CB312A3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079723-D679-4535-8CDD-06A8932291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766FBA-8679-4DE3-8625-8562502C9D71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56"/>
          <p:cNvSpPr/>
          <p:nvPr/>
        </p:nvSpPr>
        <p:spPr>
          <a:xfrm>
            <a:off x="747360" y="6313320"/>
            <a:ext cx="25628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before trastuzumab-based treat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                      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(patient #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656"/>
          <p:cNvSpPr/>
          <p:nvPr/>
        </p:nvSpPr>
        <p:spPr>
          <a:xfrm>
            <a:off x="3865320" y="6313320"/>
            <a:ext cx="24606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fter trastuzumab-based treat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                  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(patient #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56"/>
          <p:cNvSpPr/>
          <p:nvPr/>
        </p:nvSpPr>
        <p:spPr>
          <a:xfrm>
            <a:off x="285840" y="305928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H&amp;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56"/>
          <p:cNvSpPr/>
          <p:nvPr/>
        </p:nvSpPr>
        <p:spPr>
          <a:xfrm>
            <a:off x="312840" y="4906800"/>
            <a:ext cx="485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nti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Irf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656"/>
          <p:cNvSpPr/>
          <p:nvPr/>
        </p:nvSpPr>
        <p:spPr>
          <a:xfrm>
            <a:off x="550800" y="22096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656"/>
          <p:cNvSpPr/>
          <p:nvPr/>
        </p:nvSpPr>
        <p:spPr>
          <a:xfrm>
            <a:off x="3625200" y="2195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656"/>
          <p:cNvSpPr/>
          <p:nvPr/>
        </p:nvSpPr>
        <p:spPr>
          <a:xfrm>
            <a:off x="551520" y="4152960"/>
            <a:ext cx="24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656"/>
          <p:cNvSpPr/>
          <p:nvPr/>
        </p:nvSpPr>
        <p:spPr>
          <a:xfrm>
            <a:off x="3646080" y="41529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19" descr=""/>
          <p:cNvPicPr/>
          <p:nvPr/>
        </p:nvPicPr>
        <p:blipFill>
          <a:blip r:embed="rId1"/>
          <a:stretch/>
        </p:blipFill>
        <p:spPr>
          <a:xfrm>
            <a:off x="836640" y="4356000"/>
            <a:ext cx="2425680" cy="19195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7" descr=""/>
          <p:cNvPicPr/>
          <p:nvPr/>
        </p:nvPicPr>
        <p:blipFill>
          <a:blip r:embed="rId2"/>
          <a:stretch/>
        </p:blipFill>
        <p:spPr>
          <a:xfrm>
            <a:off x="3860640" y="4356000"/>
            <a:ext cx="2426040" cy="19209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3" descr=""/>
          <p:cNvPicPr/>
          <p:nvPr/>
        </p:nvPicPr>
        <p:blipFill>
          <a:blip r:embed="rId3"/>
          <a:stretch/>
        </p:blipFill>
        <p:spPr>
          <a:xfrm>
            <a:off x="836640" y="2340000"/>
            <a:ext cx="2422440" cy="19191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" descr="A picture containing fungus&#10;&#10;Description generated with high confidence"/>
          <p:cNvPicPr/>
          <p:nvPr/>
        </p:nvPicPr>
        <p:blipFill>
          <a:blip r:embed="rId4"/>
          <a:stretch/>
        </p:blipFill>
        <p:spPr>
          <a:xfrm>
            <a:off x="3860640" y="2340000"/>
            <a:ext cx="2411640" cy="1906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19T18:51:13Z</dcterms:created>
  <dc:creator>krosen</dc:creator>
  <dc:description/>
  <dc:language>en-US</dc:language>
  <cp:lastModifiedBy>kirill.rosen@hotmail.com</cp:lastModifiedBy>
  <dcterms:modified xsi:type="dcterms:W3CDTF">2018-10-18T19:32:31Z</dcterms:modified>
  <cp:revision>96</cp:revision>
  <dc:subject/>
  <dc:title>Slide 1</dc:title>
</cp:coreProperties>
</file>